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7DA14-0F94-4513-A486-2DCFA5F0BC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16844-BBF4-4AD1-86B4-D4D7B810E7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1C6E5-C6B0-4286-9AB9-AE1BF9BD03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102F8-4263-4FC5-A8F7-E860719526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5C8AF-3D55-4609-9E82-B564BB4900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E0C51-7C50-40F3-867C-CC08706B47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A9164-08E0-4DB5-AA9A-8234F7C8CC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97EF9-50D9-476B-A89B-66311705D8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FF687-7886-460B-9B68-5817EE48A0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C155A-AD87-42A1-87E0-631BED15EC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71EED-7D6B-4A76-9827-1603DEB84D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52144-7236-419A-BF36-FB99CF3608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C5E9F26-C7A1-4DC0-8DA8-F8EB532A669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216000" y="6207120"/>
            <a:ext cx="6426000" cy="13971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196920" y="2292480"/>
            <a:ext cx="6464160" cy="14094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tretch/>
        </p:blipFill>
        <p:spPr>
          <a:xfrm>
            <a:off x="216000" y="4243320"/>
            <a:ext cx="6426000" cy="1422360"/>
          </a:xfrm>
          <a:prstGeom prst="rect">
            <a:avLst/>
          </a:prstGeom>
          <a:ln w="0">
            <a:noFill/>
          </a:ln>
        </p:spPr>
      </p:pic>
      <p:sp>
        <p:nvSpPr>
          <p:cNvPr id="44" name="TextBox 23"/>
          <p:cNvSpPr/>
          <p:nvPr/>
        </p:nvSpPr>
        <p:spPr>
          <a:xfrm>
            <a:off x="152280" y="2054160"/>
            <a:ext cx="79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K =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4"/>
          <p:cNvSpPr/>
          <p:nvPr/>
        </p:nvSpPr>
        <p:spPr>
          <a:xfrm>
            <a:off x="162000" y="4017960"/>
            <a:ext cx="69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K = 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5"/>
          <p:cNvSpPr/>
          <p:nvPr/>
        </p:nvSpPr>
        <p:spPr>
          <a:xfrm>
            <a:off x="171360" y="5961240"/>
            <a:ext cx="876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K = 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2" descr=""/>
          <p:cNvPicPr/>
          <p:nvPr/>
        </p:nvPicPr>
        <p:blipFill>
          <a:blip r:embed="rId4"/>
          <a:stretch/>
        </p:blipFill>
        <p:spPr>
          <a:xfrm>
            <a:off x="216000" y="355680"/>
            <a:ext cx="6426000" cy="1396800"/>
          </a:xfrm>
          <a:prstGeom prst="rect">
            <a:avLst/>
          </a:prstGeom>
          <a:ln w="0">
            <a:noFill/>
          </a:ln>
        </p:spPr>
      </p:pic>
      <p:sp>
        <p:nvSpPr>
          <p:cNvPr id="48" name="TextBox 1"/>
          <p:cNvSpPr/>
          <p:nvPr/>
        </p:nvSpPr>
        <p:spPr>
          <a:xfrm>
            <a:off x="152280" y="108000"/>
            <a:ext cx="89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K =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"/>
          <p:cNvSpPr/>
          <p:nvPr/>
        </p:nvSpPr>
        <p:spPr>
          <a:xfrm flipV="1" rot="16200000">
            <a:off x="3916080" y="1578600"/>
            <a:ext cx="42840" cy="389160"/>
          </a:xfrm>
          <a:custGeom>
            <a:avLst/>
            <a:gdLst>
              <a:gd name="textAreaLeft" fmla="*/ 27360 w 42840"/>
              <a:gd name="textAreaRight" fmla="*/ 43200 w 42840"/>
              <a:gd name="textAreaTop" fmla="*/ 10080 h 389160"/>
              <a:gd name="textAreaBottom" fmla="*/ 379080 h 389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"/>
          <p:cNvSpPr/>
          <p:nvPr/>
        </p:nvSpPr>
        <p:spPr>
          <a:xfrm>
            <a:off x="3597480" y="1752480"/>
            <a:ext cx="65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ol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"/>
          <p:cNvSpPr/>
          <p:nvPr/>
        </p:nvSpPr>
        <p:spPr>
          <a:xfrm flipV="1" rot="16200000">
            <a:off x="5777640" y="1734840"/>
            <a:ext cx="42840" cy="76320"/>
          </a:xfrm>
          <a:custGeom>
            <a:avLst/>
            <a:gdLst>
              <a:gd name="textAreaLeft" fmla="*/ 27360 w 42840"/>
              <a:gd name="textAreaRight" fmla="*/ 43200 w 42840"/>
              <a:gd name="textAreaTop" fmla="*/ 1800 h 76320"/>
              <a:gd name="textAreaBottom" fmla="*/ 74520 h 76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"/>
          <p:cNvSpPr/>
          <p:nvPr/>
        </p:nvSpPr>
        <p:spPr>
          <a:xfrm>
            <a:off x="5384880" y="1752480"/>
            <a:ext cx="823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hrew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"/>
          <p:cNvSpPr/>
          <p:nvPr/>
        </p:nvSpPr>
        <p:spPr>
          <a:xfrm flipV="1" rot="16200000">
            <a:off x="4506840" y="3329640"/>
            <a:ext cx="42840" cy="792000"/>
          </a:xfrm>
          <a:custGeom>
            <a:avLst/>
            <a:gdLst>
              <a:gd name="textAreaLeft" fmla="*/ 27360 w 42840"/>
              <a:gd name="textAreaRight" fmla="*/ 43200 w 42840"/>
              <a:gd name="textAreaTop" fmla="*/ 20520 h 792000"/>
              <a:gd name="textAreaBottom" fmla="*/ 771480 h 792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"/>
          <p:cNvSpPr/>
          <p:nvPr/>
        </p:nvSpPr>
        <p:spPr>
          <a:xfrm>
            <a:off x="4052520" y="370692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oe de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"/>
          <p:cNvSpPr/>
          <p:nvPr/>
        </p:nvSpPr>
        <p:spPr>
          <a:xfrm flipV="1" rot="16200000">
            <a:off x="6086160" y="3450600"/>
            <a:ext cx="42840" cy="554040"/>
          </a:xfrm>
          <a:custGeom>
            <a:avLst/>
            <a:gdLst>
              <a:gd name="textAreaLeft" fmla="*/ 27360 w 42840"/>
              <a:gd name="textAreaRight" fmla="*/ 43200 w 42840"/>
              <a:gd name="textAreaTop" fmla="*/ 14400 h 554040"/>
              <a:gd name="textAreaBottom" fmla="*/ 539640 h 554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"/>
          <p:cNvSpPr/>
          <p:nvPr/>
        </p:nvSpPr>
        <p:spPr>
          <a:xfrm>
            <a:off x="5841000" y="3706920"/>
            <a:ext cx="589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ick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"/>
          <p:cNvSpPr/>
          <p:nvPr/>
        </p:nvSpPr>
        <p:spPr>
          <a:xfrm>
            <a:off x="4973040" y="565956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he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"/>
          <p:cNvSpPr/>
          <p:nvPr/>
        </p:nvSpPr>
        <p:spPr>
          <a:xfrm flipV="1" rot="16200000">
            <a:off x="5329800" y="5259600"/>
            <a:ext cx="42840" cy="857160"/>
          </a:xfrm>
          <a:custGeom>
            <a:avLst/>
            <a:gdLst>
              <a:gd name="textAreaLeft" fmla="*/ 27360 w 42840"/>
              <a:gd name="textAreaRight" fmla="*/ 43200 w 42840"/>
              <a:gd name="textAreaTop" fmla="*/ 22320 h 857160"/>
              <a:gd name="textAreaBottom" fmla="*/ 834840 h 857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"/>
          <p:cNvSpPr/>
          <p:nvPr/>
        </p:nvSpPr>
        <p:spPr>
          <a:xfrm>
            <a:off x="3463560" y="565164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d de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"/>
          <p:cNvSpPr/>
          <p:nvPr/>
        </p:nvSpPr>
        <p:spPr>
          <a:xfrm flipV="1" rot="16200000">
            <a:off x="3560400" y="5562000"/>
            <a:ext cx="50760" cy="244440"/>
          </a:xfrm>
          <a:custGeom>
            <a:avLst/>
            <a:gdLst>
              <a:gd name="textAreaLeft" fmla="*/ 32400 w 50760"/>
              <a:gd name="textAreaRight" fmla="*/ 51120 w 50760"/>
              <a:gd name="textAreaTop" fmla="*/ 6120 h 244440"/>
              <a:gd name="textAreaBottom" fmla="*/ 238320 h 2444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"/>
          <p:cNvSpPr/>
          <p:nvPr/>
        </p:nvSpPr>
        <p:spPr>
          <a:xfrm flipV="1" rot="16200000">
            <a:off x="357120" y="5556240"/>
            <a:ext cx="43200" cy="255600"/>
          </a:xfrm>
          <a:custGeom>
            <a:avLst/>
            <a:gdLst>
              <a:gd name="textAreaLeft" fmla="*/ 27720 w 43200"/>
              <a:gd name="textAreaRight" fmla="*/ 43560 w 43200"/>
              <a:gd name="textAreaTop" fmla="*/ 6480 h 255600"/>
              <a:gd name="textAreaBottom" fmla="*/ 249120 h 2556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"/>
          <p:cNvSpPr/>
          <p:nvPr/>
        </p:nvSpPr>
        <p:spPr>
          <a:xfrm flipV="1" rot="16200000">
            <a:off x="631800" y="5626080"/>
            <a:ext cx="43200" cy="115920"/>
          </a:xfrm>
          <a:custGeom>
            <a:avLst/>
            <a:gdLst>
              <a:gd name="textAreaLeft" fmla="*/ 27720 w 43200"/>
              <a:gd name="textAreaRight" fmla="*/ 43560 w 43200"/>
              <a:gd name="textAreaTop" fmla="*/ 2880 h 115920"/>
              <a:gd name="textAreaBottom" fmla="*/ 113040 h 115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"/>
          <p:cNvSpPr/>
          <p:nvPr/>
        </p:nvSpPr>
        <p:spPr>
          <a:xfrm>
            <a:off x="3960" y="5648400"/>
            <a:ext cx="66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is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"/>
          <p:cNvSpPr/>
          <p:nvPr/>
        </p:nvSpPr>
        <p:spPr>
          <a:xfrm>
            <a:off x="511200" y="5653080"/>
            <a:ext cx="66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tl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"/>
          <p:cNvSpPr/>
          <p:nvPr/>
        </p:nvSpPr>
        <p:spPr>
          <a:xfrm flipV="1" rot="16200000">
            <a:off x="6473520" y="7536960"/>
            <a:ext cx="42840" cy="176040"/>
          </a:xfrm>
          <a:custGeom>
            <a:avLst/>
            <a:gdLst>
              <a:gd name="textAreaLeft" fmla="*/ 27360 w 42840"/>
              <a:gd name="textAreaRight" fmla="*/ 43200 w 42840"/>
              <a:gd name="textAreaTop" fmla="*/ 4320 h 176040"/>
              <a:gd name="textAreaBottom" fmla="*/ 171720 h 176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5926320" y="7986960"/>
            <a:ext cx="109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ild boar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"/>
          <p:cNvSpPr/>
          <p:nvPr/>
        </p:nvSpPr>
        <p:spPr>
          <a:xfrm flipV="1" rot="16200000">
            <a:off x="6082920" y="7360560"/>
            <a:ext cx="42840" cy="522360"/>
          </a:xfrm>
          <a:custGeom>
            <a:avLst/>
            <a:gdLst>
              <a:gd name="textAreaLeft" fmla="*/ 27360 w 42840"/>
              <a:gd name="textAreaRight" fmla="*/ 43200 w 42840"/>
              <a:gd name="textAreaTop" fmla="*/ 13320 h 522360"/>
              <a:gd name="textAreaBottom" fmla="*/ 509040 h 522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"/>
          <p:cNvSpPr/>
          <p:nvPr/>
        </p:nvSpPr>
        <p:spPr>
          <a:xfrm flipV="1" rot="16200000">
            <a:off x="5775840" y="7596000"/>
            <a:ext cx="42840" cy="54000"/>
          </a:xfrm>
          <a:custGeom>
            <a:avLst/>
            <a:gdLst>
              <a:gd name="textAreaLeft" fmla="*/ 27360 w 42840"/>
              <a:gd name="textAreaRight" fmla="*/ 43200 w 42840"/>
              <a:gd name="textAreaTop" fmla="*/ 1080 h 54000"/>
              <a:gd name="textAreaBottom" fmla="*/ 52920 h 5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040" bIns="5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"/>
          <p:cNvSpPr/>
          <p:nvPr/>
        </p:nvSpPr>
        <p:spPr>
          <a:xfrm flipV="1" rot="16200000">
            <a:off x="3929400" y="7461360"/>
            <a:ext cx="42840" cy="345960"/>
          </a:xfrm>
          <a:custGeom>
            <a:avLst/>
            <a:gdLst>
              <a:gd name="textAreaLeft" fmla="*/ 27360 w 42840"/>
              <a:gd name="textAreaRight" fmla="*/ 43200 w 42840"/>
              <a:gd name="textAreaTop" fmla="*/ 9000 h 345960"/>
              <a:gd name="textAreaBottom" fmla="*/ 336960 h 345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"/>
          <p:cNvSpPr/>
          <p:nvPr/>
        </p:nvSpPr>
        <p:spPr>
          <a:xfrm flipV="1" rot="16200000">
            <a:off x="4502880" y="7254720"/>
            <a:ext cx="44280" cy="757440"/>
          </a:xfrm>
          <a:custGeom>
            <a:avLst/>
            <a:gdLst>
              <a:gd name="textAreaLeft" fmla="*/ 28440 w 44280"/>
              <a:gd name="textAreaRight" fmla="*/ 44640 w 44280"/>
              <a:gd name="textAreaTop" fmla="*/ 19440 h 757440"/>
              <a:gd name="textAreaBottom" fmla="*/ 738000 h 7574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"/>
          <p:cNvSpPr/>
          <p:nvPr/>
        </p:nvSpPr>
        <p:spPr>
          <a:xfrm flipV="1" rot="16200000">
            <a:off x="350640" y="7536600"/>
            <a:ext cx="42840" cy="223920"/>
          </a:xfrm>
          <a:custGeom>
            <a:avLst/>
            <a:gdLst>
              <a:gd name="textAreaLeft" fmla="*/ 27360 w 42840"/>
              <a:gd name="textAreaRight" fmla="*/ 43200 w 42840"/>
              <a:gd name="textAreaTop" fmla="*/ 5760 h 223920"/>
              <a:gd name="textAreaBottom" fmla="*/ 218160 h 223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"/>
          <p:cNvSpPr/>
          <p:nvPr/>
        </p:nvSpPr>
        <p:spPr>
          <a:xfrm flipV="1" rot="16200000">
            <a:off x="3547080" y="7523280"/>
            <a:ext cx="42840" cy="212760"/>
          </a:xfrm>
          <a:custGeom>
            <a:avLst/>
            <a:gdLst>
              <a:gd name="textAreaLeft" fmla="*/ 27360 w 42840"/>
              <a:gd name="textAreaRight" fmla="*/ 43200 w 42840"/>
              <a:gd name="textAreaTop" fmla="*/ 5400 h 212760"/>
              <a:gd name="textAreaBottom" fmla="*/ 207360 h 2127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"/>
          <p:cNvSpPr/>
          <p:nvPr/>
        </p:nvSpPr>
        <p:spPr>
          <a:xfrm flipV="1" rot="16200000">
            <a:off x="5315400" y="7220160"/>
            <a:ext cx="50760" cy="820440"/>
          </a:xfrm>
          <a:custGeom>
            <a:avLst/>
            <a:gdLst>
              <a:gd name="textAreaLeft" fmla="*/ 32400 w 50760"/>
              <a:gd name="textAreaRight" fmla="*/ 51120 w 50760"/>
              <a:gd name="textAreaTop" fmla="*/ 21240 h 820440"/>
              <a:gd name="textAreaBottom" fmla="*/ 799200 h 8204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5785920" y="7754760"/>
            <a:ext cx="589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ick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5368320" y="7851960"/>
            <a:ext cx="823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hrew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4943520" y="781200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he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"/>
          <p:cNvSpPr/>
          <p:nvPr/>
        </p:nvSpPr>
        <p:spPr>
          <a:xfrm rot="16200000">
            <a:off x="4044240" y="791532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oe de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"/>
          <p:cNvSpPr/>
          <p:nvPr/>
        </p:nvSpPr>
        <p:spPr>
          <a:xfrm rot="16200000">
            <a:off x="3596400" y="7778520"/>
            <a:ext cx="65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ol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"/>
          <p:cNvSpPr/>
          <p:nvPr/>
        </p:nvSpPr>
        <p:spPr>
          <a:xfrm flipV="1" rot="16200000">
            <a:off x="3704400" y="7605720"/>
            <a:ext cx="42840" cy="54000"/>
          </a:xfrm>
          <a:custGeom>
            <a:avLst/>
            <a:gdLst>
              <a:gd name="textAreaLeft" fmla="*/ 27360 w 42840"/>
              <a:gd name="textAreaRight" fmla="*/ 43200 w 42840"/>
              <a:gd name="textAreaTop" fmla="*/ 1080 h 54000"/>
              <a:gd name="textAreaBottom" fmla="*/ 52920 h 5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040" bIns="5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"/>
          <p:cNvSpPr/>
          <p:nvPr/>
        </p:nvSpPr>
        <p:spPr>
          <a:xfrm rot="16200000">
            <a:off x="3197520" y="7952040"/>
            <a:ext cx="1015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d fox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"/>
          <p:cNvSpPr/>
          <p:nvPr/>
        </p:nvSpPr>
        <p:spPr>
          <a:xfrm flipV="1" rot="16200000">
            <a:off x="635760" y="7610400"/>
            <a:ext cx="42840" cy="85680"/>
          </a:xfrm>
          <a:custGeom>
            <a:avLst/>
            <a:gdLst>
              <a:gd name="textAreaLeft" fmla="*/ 27360 w 42840"/>
              <a:gd name="textAreaRight" fmla="*/ 43200 w 42840"/>
              <a:gd name="textAreaTop" fmla="*/ 2160 h 85680"/>
              <a:gd name="textAreaBottom" fmla="*/ 83520 h 85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4560" bIns="345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"/>
          <p:cNvSpPr/>
          <p:nvPr/>
        </p:nvSpPr>
        <p:spPr>
          <a:xfrm flipV="1" rot="16200000">
            <a:off x="2500920" y="7407360"/>
            <a:ext cx="42840" cy="444240"/>
          </a:xfrm>
          <a:custGeom>
            <a:avLst/>
            <a:gdLst>
              <a:gd name="textAreaLeft" fmla="*/ 27360 w 42840"/>
              <a:gd name="textAreaRight" fmla="*/ 43200 w 42840"/>
              <a:gd name="textAreaTop" fmla="*/ 11520 h 444240"/>
              <a:gd name="textAreaBottom" fmla="*/ 432720 h 4442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"/>
          <p:cNvSpPr/>
          <p:nvPr/>
        </p:nvSpPr>
        <p:spPr>
          <a:xfrm flipV="1" rot="16200000">
            <a:off x="3078720" y="7292880"/>
            <a:ext cx="42840" cy="673200"/>
          </a:xfrm>
          <a:custGeom>
            <a:avLst/>
            <a:gdLst>
              <a:gd name="textAreaLeft" fmla="*/ 27360 w 42840"/>
              <a:gd name="textAreaRight" fmla="*/ 43200 w 42840"/>
              <a:gd name="textAreaTop" fmla="*/ 17280 h 673200"/>
              <a:gd name="textAreaBottom" fmla="*/ 655920 h 673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"/>
          <p:cNvSpPr/>
          <p:nvPr/>
        </p:nvSpPr>
        <p:spPr>
          <a:xfrm rot="16200000">
            <a:off x="3066480" y="791532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d de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"/>
          <p:cNvSpPr/>
          <p:nvPr/>
        </p:nvSpPr>
        <p:spPr>
          <a:xfrm rot="16200000">
            <a:off x="2623680" y="7891920"/>
            <a:ext cx="90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uman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"/>
          <p:cNvSpPr/>
          <p:nvPr/>
        </p:nvSpPr>
        <p:spPr>
          <a:xfrm rot="16200000">
            <a:off x="2088000" y="7852680"/>
            <a:ext cx="79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ors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"/>
          <p:cNvSpPr/>
          <p:nvPr/>
        </p:nvSpPr>
        <p:spPr>
          <a:xfrm flipV="1" rot="16200000">
            <a:off x="1180440" y="7168320"/>
            <a:ext cx="56880" cy="976320"/>
          </a:xfrm>
          <a:custGeom>
            <a:avLst/>
            <a:gdLst>
              <a:gd name="textAreaLeft" fmla="*/ 36360 w 56880"/>
              <a:gd name="textAreaRight" fmla="*/ 57240 w 56880"/>
              <a:gd name="textAreaTop" fmla="*/ 25200 h 976320"/>
              <a:gd name="textAreaBottom" fmla="*/ 951120 h 976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"/>
          <p:cNvSpPr/>
          <p:nvPr/>
        </p:nvSpPr>
        <p:spPr>
          <a:xfrm flipV="1" rot="16200000">
            <a:off x="1999080" y="7381800"/>
            <a:ext cx="55800" cy="511200"/>
          </a:xfrm>
          <a:custGeom>
            <a:avLst/>
            <a:gdLst>
              <a:gd name="textAreaLeft" fmla="*/ 35640 w 55800"/>
              <a:gd name="textAreaRight" fmla="*/ 56160 w 55800"/>
              <a:gd name="textAreaTop" fmla="*/ 13320 h 511200"/>
              <a:gd name="textAreaBottom" fmla="*/ 497880 h 511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"/>
          <p:cNvSpPr/>
          <p:nvPr/>
        </p:nvSpPr>
        <p:spPr>
          <a:xfrm rot="16200000">
            <a:off x="1407960" y="8037000"/>
            <a:ext cx="118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dgehog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"/>
          <p:cNvSpPr/>
          <p:nvPr/>
        </p:nvSpPr>
        <p:spPr>
          <a:xfrm flipV="1" rot="16200000">
            <a:off x="545760" y="7625880"/>
            <a:ext cx="42840" cy="45720"/>
          </a:xfrm>
          <a:custGeom>
            <a:avLst/>
            <a:gdLst>
              <a:gd name="textAreaLeft" fmla="*/ 27360 w 42840"/>
              <a:gd name="textAreaRight" fmla="*/ 43200 w 42840"/>
              <a:gd name="textAreaTop" fmla="*/ 1080 h 45720"/>
              <a:gd name="textAreaBottom" fmla="*/ 44640 h 45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240" bIns="-32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"/>
          <p:cNvSpPr/>
          <p:nvPr/>
        </p:nvSpPr>
        <p:spPr>
          <a:xfrm flipV="1" rot="16200000">
            <a:off x="494280" y="7637400"/>
            <a:ext cx="42840" cy="31680"/>
          </a:xfrm>
          <a:custGeom>
            <a:avLst/>
            <a:gdLst>
              <a:gd name="textAreaLeft" fmla="*/ 27360 w 42840"/>
              <a:gd name="textAreaRight" fmla="*/ 43200 w 42840"/>
              <a:gd name="textAreaTop" fmla="*/ 720 h 31680"/>
              <a:gd name="textAreaBottom" fmla="*/ 30960 h 31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560" bIns="-165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"/>
          <p:cNvSpPr/>
          <p:nvPr/>
        </p:nvSpPr>
        <p:spPr>
          <a:xfrm flipV="1" rot="16200000">
            <a:off x="1710360" y="7618320"/>
            <a:ext cx="42840" cy="28800"/>
          </a:xfrm>
          <a:custGeom>
            <a:avLst/>
            <a:gdLst>
              <a:gd name="textAreaLeft" fmla="*/ 27360 w 42840"/>
              <a:gd name="textAreaRight" fmla="*/ 43200 w 42840"/>
              <a:gd name="textAreaTop" fmla="*/ 720 h 28800"/>
              <a:gd name="textAreaBottom" fmla="*/ 28080 h 2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440" bIns="-19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"/>
          <p:cNvSpPr/>
          <p:nvPr/>
        </p:nvSpPr>
        <p:spPr>
          <a:xfrm rot="16200000">
            <a:off x="1414440" y="77374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oa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"/>
          <p:cNvSpPr/>
          <p:nvPr/>
        </p:nvSpPr>
        <p:spPr>
          <a:xfrm rot="16200000">
            <a:off x="864720" y="7756560"/>
            <a:ext cx="62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og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"/>
          <p:cNvSpPr/>
          <p:nvPr/>
        </p:nvSpPr>
        <p:spPr>
          <a:xfrm rot="16200000">
            <a:off x="22320" y="7788240"/>
            <a:ext cx="66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is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"/>
          <p:cNvSpPr/>
          <p:nvPr/>
        </p:nvSpPr>
        <p:spPr>
          <a:xfrm rot="16200000">
            <a:off x="167760" y="8266680"/>
            <a:ext cx="55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123120" y="8451360"/>
            <a:ext cx="938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hamoi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"/>
          <p:cNvSpPr/>
          <p:nvPr/>
        </p:nvSpPr>
        <p:spPr>
          <a:xfrm rot="16200000">
            <a:off x="306720" y="7795440"/>
            <a:ext cx="66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tl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"/>
          <p:cNvSpPr/>
          <p:nvPr/>
        </p:nvSpPr>
        <p:spPr>
          <a:xfrm flipV="1" rot="16200000">
            <a:off x="3081240" y="5347440"/>
            <a:ext cx="50760" cy="673200"/>
          </a:xfrm>
          <a:custGeom>
            <a:avLst/>
            <a:gdLst>
              <a:gd name="textAreaLeft" fmla="*/ 32400 w 50760"/>
              <a:gd name="textAreaRight" fmla="*/ 51120 w 50760"/>
              <a:gd name="textAreaTop" fmla="*/ 17280 h 673200"/>
              <a:gd name="textAreaBottom" fmla="*/ 655920 h 673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"/>
          <p:cNvSpPr/>
          <p:nvPr/>
        </p:nvSpPr>
        <p:spPr>
          <a:xfrm>
            <a:off x="2654280" y="5654520"/>
            <a:ext cx="90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uman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1"/>
          <p:cNvSpPr/>
          <p:nvPr/>
        </p:nvSpPr>
        <p:spPr>
          <a:xfrm>
            <a:off x="496800" y="682560"/>
            <a:ext cx="5862600" cy="366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4. DISTRUCT plots for runs of STRUCTURE assuming two to five clusters 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(K = 2 – 5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ISTRUCT plots for runs of STRUCTURE assuming two to five clusters are shown (K = number of clusters).  A data set of 518 variable sites from the seven MLST loci was used. 383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A. phagocytophilum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strains from humans, animals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I. ricinu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icks were included. Each strain is represented by a vertical line, which is partitioned into two to five colors that represent its estimated membership fractions in K = 2 to K = 5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lusters. Labels below the plots provide the host origin. Black vertical lines separate the strains of different host origin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9T17:32:27Z</dcterms:created>
  <dc:creator>Matthew Aardema</dc:creator>
  <dc:description/>
  <dc:language>en-US</dc:language>
  <cp:lastModifiedBy>Friederike von Loewenich</cp:lastModifiedBy>
  <dcterms:modified xsi:type="dcterms:W3CDTF">2013-09-29T16:59:35Z</dcterms:modified>
  <cp:revision>23</cp:revision>
  <dc:subject/>
  <dc:title>PowerPoint Presentation</dc:title>
</cp:coreProperties>
</file>